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4"/>
    <p:sldMasterId id="2147484459" r:id="rId5"/>
    <p:sldMasterId id="2147484471" r:id="rId6"/>
  </p:sldMasterIdLst>
  <p:handoutMasterIdLst>
    <p:handoutMasterId r:id="rId13"/>
  </p:handoutMasterIdLst>
  <p:sldIdLst>
    <p:sldId id="258" r:id="rId7"/>
    <p:sldId id="264" r:id="rId8"/>
    <p:sldId id="266" r:id="rId9"/>
    <p:sldId id="268" r:id="rId10"/>
    <p:sldId id="269" r:id="rId11"/>
    <p:sldId id="265" r:id="rId12"/>
  </p:sldIdLst>
  <p:sldSz cx="9144000" cy="6858000" type="screen4x3"/>
  <p:notesSz cx="6858000" cy="9144000"/>
  <p:custDataLst>
    <p:tags r:id="rId14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331B6A3-0612-495D-A603-D2BFBF313FAE}" v="71" dt="2022-07-06T07:47:49.96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809" autoAdjust="0"/>
    <p:restoredTop sz="94660"/>
  </p:normalViewPr>
  <p:slideViewPr>
    <p:cSldViewPr>
      <p:cViewPr varScale="1">
        <p:scale>
          <a:sx n="114" d="100"/>
          <a:sy n="114" d="100"/>
        </p:scale>
        <p:origin x="1344" y="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2.xml"/><Relationship Id="rId13" Type="http://schemas.openxmlformats.org/officeDocument/2006/relationships/handoutMaster" Target="handoutMasters/handoutMaster1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1.xml"/><Relationship Id="rId12" Type="http://schemas.openxmlformats.org/officeDocument/2006/relationships/slide" Target="slides/slide6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Master" Target="slideMasters/slideMaster3.xml"/><Relationship Id="rId11" Type="http://schemas.openxmlformats.org/officeDocument/2006/relationships/slide" Target="slides/slide5.xml"/><Relationship Id="rId5" Type="http://schemas.openxmlformats.org/officeDocument/2006/relationships/slideMaster" Target="slideMasters/slideMaster2.xml"/><Relationship Id="rId15" Type="http://schemas.openxmlformats.org/officeDocument/2006/relationships/presProps" Target="presProps.xml"/><Relationship Id="rId10" Type="http://schemas.openxmlformats.org/officeDocument/2006/relationships/slide" Target="slides/slide4.xml"/><Relationship Id="rId19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3.xml"/><Relationship Id="rId14" Type="http://schemas.openxmlformats.org/officeDocument/2006/relationships/tags" Target="tags/tag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in Lindström" userId="723b82ab-0209-45d5-96e3-8656267ad461" providerId="ADAL" clId="{F331B6A3-0612-495D-A603-D2BFBF313FAE}"/>
    <pc:docChg chg="undo redo custSel addSld delSld modSld sldOrd">
      <pc:chgData name="Elin Lindström" userId="723b82ab-0209-45d5-96e3-8656267ad461" providerId="ADAL" clId="{F331B6A3-0612-495D-A603-D2BFBF313FAE}" dt="2022-07-06T07:58:58.719" v="1396" actId="255"/>
      <pc:docMkLst>
        <pc:docMk/>
      </pc:docMkLst>
      <pc:sldChg chg="addSp delSp modSp mod">
        <pc:chgData name="Elin Lindström" userId="723b82ab-0209-45d5-96e3-8656267ad461" providerId="ADAL" clId="{F331B6A3-0612-495D-A603-D2BFBF313FAE}" dt="2022-06-27T13:52:33.663" v="415" actId="113"/>
        <pc:sldMkLst>
          <pc:docMk/>
          <pc:sldMk cId="0" sldId="258"/>
        </pc:sldMkLst>
        <pc:spChg chg="del">
          <ac:chgData name="Elin Lindström" userId="723b82ab-0209-45d5-96e3-8656267ad461" providerId="ADAL" clId="{F331B6A3-0612-495D-A603-D2BFBF313FAE}" dt="2022-06-27T13:48:53.036" v="316" actId="478"/>
          <ac:spMkLst>
            <pc:docMk/>
            <pc:sldMk cId="0" sldId="258"/>
            <ac:spMk id="2" creationId="{00000000-0000-0000-0000-000000000000}"/>
          </ac:spMkLst>
        </pc:spChg>
        <pc:spChg chg="del">
          <ac:chgData name="Elin Lindström" userId="723b82ab-0209-45d5-96e3-8656267ad461" providerId="ADAL" clId="{F331B6A3-0612-495D-A603-D2BFBF313FAE}" dt="2022-06-16T11:36:56.160" v="75" actId="478"/>
          <ac:spMkLst>
            <pc:docMk/>
            <pc:sldMk cId="0" sldId="258"/>
            <ac:spMk id="10" creationId="{00000000-0000-0000-0000-000000000000}"/>
          </ac:spMkLst>
        </pc:spChg>
        <pc:spChg chg="mod">
          <ac:chgData name="Elin Lindström" userId="723b82ab-0209-45d5-96e3-8656267ad461" providerId="ADAL" clId="{F331B6A3-0612-495D-A603-D2BFBF313FAE}" dt="2022-06-27T13:52:33.663" v="415" actId="113"/>
          <ac:spMkLst>
            <pc:docMk/>
            <pc:sldMk cId="0" sldId="258"/>
            <ac:spMk id="4102" creationId="{00000000-0000-0000-0000-000000000000}"/>
          </ac:spMkLst>
        </pc:spChg>
        <pc:spChg chg="mod">
          <ac:chgData name="Elin Lindström" userId="723b82ab-0209-45d5-96e3-8656267ad461" providerId="ADAL" clId="{F331B6A3-0612-495D-A603-D2BFBF313FAE}" dt="2022-06-16T11:36:35.890" v="71" actId="1076"/>
          <ac:spMkLst>
            <pc:docMk/>
            <pc:sldMk cId="0" sldId="258"/>
            <ac:spMk id="4103" creationId="{00000000-0000-0000-0000-000000000000}"/>
          </ac:spMkLst>
        </pc:spChg>
        <pc:spChg chg="del">
          <ac:chgData name="Elin Lindström" userId="723b82ab-0209-45d5-96e3-8656267ad461" providerId="ADAL" clId="{F331B6A3-0612-495D-A603-D2BFBF313FAE}" dt="2022-06-16T11:36:31.030" v="68" actId="478"/>
          <ac:spMkLst>
            <pc:docMk/>
            <pc:sldMk cId="0" sldId="258"/>
            <ac:spMk id="4104" creationId="{00000000-0000-0000-0000-000000000000}"/>
          </ac:spMkLst>
        </pc:spChg>
        <pc:picChg chg="add mod">
          <ac:chgData name="Elin Lindström" userId="723b82ab-0209-45d5-96e3-8656267ad461" providerId="ADAL" clId="{F331B6A3-0612-495D-A603-D2BFBF313FAE}" dt="2022-06-27T13:49:02.070" v="318" actId="1076"/>
          <ac:picMkLst>
            <pc:docMk/>
            <pc:sldMk cId="0" sldId="258"/>
            <ac:picMk id="4" creationId="{238951FD-718A-4BFD-97B7-6A08221B5CA5}"/>
          </ac:picMkLst>
        </pc:picChg>
        <pc:picChg chg="add mod">
          <ac:chgData name="Elin Lindström" userId="723b82ab-0209-45d5-96e3-8656267ad461" providerId="ADAL" clId="{F331B6A3-0612-495D-A603-D2BFBF313FAE}" dt="2022-06-27T13:48:57.046" v="317" actId="1076"/>
          <ac:picMkLst>
            <pc:docMk/>
            <pc:sldMk cId="0" sldId="258"/>
            <ac:picMk id="5" creationId="{A1341921-491F-4F68-AFF8-FA7AC03034CB}"/>
          </ac:picMkLst>
        </pc:picChg>
        <pc:picChg chg="add mod modCrop">
          <ac:chgData name="Elin Lindström" userId="723b82ab-0209-45d5-96e3-8656267ad461" providerId="ADAL" clId="{F331B6A3-0612-495D-A603-D2BFBF313FAE}" dt="2022-06-27T13:48:57.046" v="317" actId="1076"/>
          <ac:picMkLst>
            <pc:docMk/>
            <pc:sldMk cId="0" sldId="258"/>
            <ac:picMk id="7" creationId="{286EE8F4-570E-41D9-9468-3F14CA8F361E}"/>
          </ac:picMkLst>
        </pc:picChg>
      </pc:sldChg>
      <pc:sldChg chg="modSp mod">
        <pc:chgData name="Elin Lindström" userId="723b82ab-0209-45d5-96e3-8656267ad461" providerId="ADAL" clId="{F331B6A3-0612-495D-A603-D2BFBF313FAE}" dt="2022-07-06T07:53:13.613" v="1394" actId="20577"/>
        <pc:sldMkLst>
          <pc:docMk/>
          <pc:sldMk cId="0" sldId="264"/>
        </pc:sldMkLst>
        <pc:spChg chg="mod">
          <ac:chgData name="Elin Lindström" userId="723b82ab-0209-45d5-96e3-8656267ad461" providerId="ADAL" clId="{F331B6A3-0612-495D-A603-D2BFBF313FAE}" dt="2022-07-06T07:53:13.613" v="1394" actId="20577"/>
          <ac:spMkLst>
            <pc:docMk/>
            <pc:sldMk cId="0" sldId="264"/>
            <ac:spMk id="6151" creationId="{00000000-0000-0000-0000-000000000000}"/>
          </ac:spMkLst>
        </pc:spChg>
      </pc:sldChg>
      <pc:sldChg chg="modSp mod">
        <pc:chgData name="Elin Lindström" userId="723b82ab-0209-45d5-96e3-8656267ad461" providerId="ADAL" clId="{F331B6A3-0612-495D-A603-D2BFBF313FAE}" dt="2022-07-06T07:58:58.719" v="1396" actId="255"/>
        <pc:sldMkLst>
          <pc:docMk/>
          <pc:sldMk cId="2545659868" sldId="265"/>
        </pc:sldMkLst>
        <pc:spChg chg="mod">
          <ac:chgData name="Elin Lindström" userId="723b82ab-0209-45d5-96e3-8656267ad461" providerId="ADAL" clId="{F331B6A3-0612-495D-A603-D2BFBF313FAE}" dt="2022-07-06T07:58:58.719" v="1396" actId="255"/>
          <ac:spMkLst>
            <pc:docMk/>
            <pc:sldMk cId="2545659868" sldId="265"/>
            <ac:spMk id="6151" creationId="{00000000-0000-0000-0000-000000000000}"/>
          </ac:spMkLst>
        </pc:spChg>
      </pc:sldChg>
      <pc:sldChg chg="modSp mod">
        <pc:chgData name="Elin Lindström" userId="723b82ab-0209-45d5-96e3-8656267ad461" providerId="ADAL" clId="{F331B6A3-0612-495D-A603-D2BFBF313FAE}" dt="2022-06-29T11:41:08.833" v="992" actId="255"/>
        <pc:sldMkLst>
          <pc:docMk/>
          <pc:sldMk cId="3786696485" sldId="266"/>
        </pc:sldMkLst>
        <pc:spChg chg="mod">
          <ac:chgData name="Elin Lindström" userId="723b82ab-0209-45d5-96e3-8656267ad461" providerId="ADAL" clId="{F331B6A3-0612-495D-A603-D2BFBF313FAE}" dt="2022-06-29T11:41:08.833" v="992" actId="255"/>
          <ac:spMkLst>
            <pc:docMk/>
            <pc:sldMk cId="3786696485" sldId="266"/>
            <ac:spMk id="6151" creationId="{00000000-0000-0000-0000-000000000000}"/>
          </ac:spMkLst>
        </pc:spChg>
      </pc:sldChg>
      <pc:sldChg chg="addSp delSp modSp del mod">
        <pc:chgData name="Elin Lindström" userId="723b82ab-0209-45d5-96e3-8656267ad461" providerId="ADAL" clId="{F331B6A3-0612-495D-A603-D2BFBF313FAE}" dt="2022-06-27T14:17:14.765" v="577" actId="47"/>
        <pc:sldMkLst>
          <pc:docMk/>
          <pc:sldMk cId="218645169" sldId="267"/>
        </pc:sldMkLst>
        <pc:spChg chg="add mod">
          <ac:chgData name="Elin Lindström" userId="723b82ab-0209-45d5-96e3-8656267ad461" providerId="ADAL" clId="{F331B6A3-0612-495D-A603-D2BFBF313FAE}" dt="2022-06-16T12:30:31.406" v="108" actId="478"/>
          <ac:spMkLst>
            <pc:docMk/>
            <pc:sldMk cId="218645169" sldId="267"/>
            <ac:spMk id="2" creationId="{E008A45B-507E-4620-89D2-4D26BF5FBD07}"/>
          </ac:spMkLst>
        </pc:spChg>
        <pc:spChg chg="add mod">
          <ac:chgData name="Elin Lindström" userId="723b82ab-0209-45d5-96e3-8656267ad461" providerId="ADAL" clId="{F331B6A3-0612-495D-A603-D2BFBF313FAE}" dt="2022-06-16T12:31:26.297" v="115" actId="1076"/>
          <ac:spMkLst>
            <pc:docMk/>
            <pc:sldMk cId="218645169" sldId="267"/>
            <ac:spMk id="12" creationId="{87FEBA38-BA13-4D33-9F30-756D27D7A099}"/>
          </ac:spMkLst>
        </pc:spChg>
        <pc:spChg chg="add mod">
          <ac:chgData name="Elin Lindström" userId="723b82ab-0209-45d5-96e3-8656267ad461" providerId="ADAL" clId="{F331B6A3-0612-495D-A603-D2BFBF313FAE}" dt="2022-06-16T12:31:19.885" v="114" actId="1076"/>
          <ac:spMkLst>
            <pc:docMk/>
            <pc:sldMk cId="218645169" sldId="267"/>
            <ac:spMk id="13" creationId="{B98EBCF9-3842-4706-A28B-057B5278E335}"/>
          </ac:spMkLst>
        </pc:spChg>
        <pc:spChg chg="del mod">
          <ac:chgData name="Elin Lindström" userId="723b82ab-0209-45d5-96e3-8656267ad461" providerId="ADAL" clId="{F331B6A3-0612-495D-A603-D2BFBF313FAE}" dt="2022-06-16T12:30:31.406" v="108" actId="478"/>
          <ac:spMkLst>
            <pc:docMk/>
            <pc:sldMk cId="218645169" sldId="267"/>
            <ac:spMk id="6151" creationId="{00000000-0000-0000-0000-000000000000}"/>
          </ac:spMkLst>
        </pc:spChg>
        <pc:picChg chg="add mod">
          <ac:chgData name="Elin Lindström" userId="723b82ab-0209-45d5-96e3-8656267ad461" providerId="ADAL" clId="{F331B6A3-0612-495D-A603-D2BFBF313FAE}" dt="2022-06-16T12:31:13.889" v="113" actId="1076"/>
          <ac:picMkLst>
            <pc:docMk/>
            <pc:sldMk cId="218645169" sldId="267"/>
            <ac:picMk id="9" creationId="{08C29C1D-22C4-4FD4-BFDD-CE504F037ADE}"/>
          </ac:picMkLst>
        </pc:picChg>
      </pc:sldChg>
      <pc:sldChg chg="addSp delSp modSp mod ord">
        <pc:chgData name="Elin Lindström" userId="723b82ab-0209-45d5-96e3-8656267ad461" providerId="ADAL" clId="{F331B6A3-0612-495D-A603-D2BFBF313FAE}" dt="2022-07-06T07:52:23.719" v="1393"/>
        <pc:sldMkLst>
          <pc:docMk/>
          <pc:sldMk cId="1176960746" sldId="268"/>
        </pc:sldMkLst>
        <pc:spChg chg="add mod">
          <ac:chgData name="Elin Lindström" userId="723b82ab-0209-45d5-96e3-8656267ad461" providerId="ADAL" clId="{F331B6A3-0612-495D-A603-D2BFBF313FAE}" dt="2022-07-06T07:44:18.499" v="1204" actId="5793"/>
          <ac:spMkLst>
            <pc:docMk/>
            <pc:sldMk cId="1176960746" sldId="268"/>
            <ac:spMk id="2" creationId="{8947D6FB-4FF8-4938-A5DD-B64573F53F82}"/>
          </ac:spMkLst>
        </pc:spChg>
        <pc:spChg chg="add mod">
          <ac:chgData name="Elin Lindström" userId="723b82ab-0209-45d5-96e3-8656267ad461" providerId="ADAL" clId="{F331B6A3-0612-495D-A603-D2BFBF313FAE}" dt="2022-07-06T07:50:26.766" v="1365" actId="1037"/>
          <ac:spMkLst>
            <pc:docMk/>
            <pc:sldMk cId="1176960746" sldId="268"/>
            <ac:spMk id="5" creationId="{DA2B875C-F9FB-483A-AE0A-0012ADF0226E}"/>
          </ac:spMkLst>
        </pc:spChg>
        <pc:spChg chg="add mod ord">
          <ac:chgData name="Elin Lindström" userId="723b82ab-0209-45d5-96e3-8656267ad461" providerId="ADAL" clId="{F331B6A3-0612-495D-A603-D2BFBF313FAE}" dt="2022-07-06T07:50:26.766" v="1365" actId="1037"/>
          <ac:spMkLst>
            <pc:docMk/>
            <pc:sldMk cId="1176960746" sldId="268"/>
            <ac:spMk id="6" creationId="{BE11B163-3389-4FBA-B2CD-B34182703C67}"/>
          </ac:spMkLst>
        </pc:spChg>
        <pc:spChg chg="add mod">
          <ac:chgData name="Elin Lindström" userId="723b82ab-0209-45d5-96e3-8656267ad461" providerId="ADAL" clId="{F331B6A3-0612-495D-A603-D2BFBF313FAE}" dt="2022-07-06T07:50:26.766" v="1365" actId="1037"/>
          <ac:spMkLst>
            <pc:docMk/>
            <pc:sldMk cId="1176960746" sldId="268"/>
            <ac:spMk id="15" creationId="{9BD947E6-B5C9-4F52-95CF-75DB87D7473F}"/>
          </ac:spMkLst>
        </pc:spChg>
        <pc:spChg chg="add mod">
          <ac:chgData name="Elin Lindström" userId="723b82ab-0209-45d5-96e3-8656267ad461" providerId="ADAL" clId="{F331B6A3-0612-495D-A603-D2BFBF313FAE}" dt="2022-07-06T07:50:26.766" v="1365" actId="1037"/>
          <ac:spMkLst>
            <pc:docMk/>
            <pc:sldMk cId="1176960746" sldId="268"/>
            <ac:spMk id="16" creationId="{B7040341-421D-4127-8834-6C589EF6C1D4}"/>
          </ac:spMkLst>
        </pc:spChg>
        <pc:spChg chg="del mod">
          <ac:chgData name="Elin Lindström" userId="723b82ab-0209-45d5-96e3-8656267ad461" providerId="ADAL" clId="{F331B6A3-0612-495D-A603-D2BFBF313FAE}" dt="2022-06-29T11:29:17.451" v="633" actId="478"/>
          <ac:spMkLst>
            <pc:docMk/>
            <pc:sldMk cId="1176960746" sldId="268"/>
            <ac:spMk id="6151" creationId="{00000000-0000-0000-0000-000000000000}"/>
          </ac:spMkLst>
        </pc:spChg>
        <pc:picChg chg="add mod modCrop">
          <ac:chgData name="Elin Lindström" userId="723b82ab-0209-45d5-96e3-8656267ad461" providerId="ADAL" clId="{F331B6A3-0612-495D-A603-D2BFBF313FAE}" dt="2022-07-06T07:50:26.766" v="1365" actId="1037"/>
          <ac:picMkLst>
            <pc:docMk/>
            <pc:sldMk cId="1176960746" sldId="268"/>
            <ac:picMk id="3" creationId="{5DBF7D41-35FE-4F9C-B557-1E11E16600F8}"/>
          </ac:picMkLst>
        </pc:picChg>
        <pc:picChg chg="add del mod modCrop">
          <ac:chgData name="Elin Lindström" userId="723b82ab-0209-45d5-96e3-8656267ad461" providerId="ADAL" clId="{F331B6A3-0612-495D-A603-D2BFBF313FAE}" dt="2022-06-29T11:32:00.760" v="711" actId="21"/>
          <ac:picMkLst>
            <pc:docMk/>
            <pc:sldMk cId="1176960746" sldId="268"/>
            <ac:picMk id="9" creationId="{F4EFD8C8-2810-4BC4-9065-B124311C90C0}"/>
          </ac:picMkLst>
        </pc:picChg>
        <pc:picChg chg="add del mod modCrop">
          <ac:chgData name="Elin Lindström" userId="723b82ab-0209-45d5-96e3-8656267ad461" providerId="ADAL" clId="{F331B6A3-0612-495D-A603-D2BFBF313FAE}" dt="2022-06-29T11:32:00.760" v="711" actId="21"/>
          <ac:picMkLst>
            <pc:docMk/>
            <pc:sldMk cId="1176960746" sldId="268"/>
            <ac:picMk id="12" creationId="{3EB0715F-9D78-4656-80AD-D612388CD614}"/>
          </ac:picMkLst>
        </pc:picChg>
        <pc:picChg chg="add del mod">
          <ac:chgData name="Elin Lindström" userId="723b82ab-0209-45d5-96e3-8656267ad461" providerId="ADAL" clId="{F331B6A3-0612-495D-A603-D2BFBF313FAE}" dt="2022-06-29T11:32:03.673" v="713"/>
          <ac:picMkLst>
            <pc:docMk/>
            <pc:sldMk cId="1176960746" sldId="268"/>
            <ac:picMk id="13" creationId="{39192482-7044-41B1-9077-D48411DD85E4}"/>
          </ac:picMkLst>
        </pc:picChg>
        <pc:picChg chg="add del mod">
          <ac:chgData name="Elin Lindström" userId="723b82ab-0209-45d5-96e3-8656267ad461" providerId="ADAL" clId="{F331B6A3-0612-495D-A603-D2BFBF313FAE}" dt="2022-06-29T11:32:03.673" v="713"/>
          <ac:picMkLst>
            <pc:docMk/>
            <pc:sldMk cId="1176960746" sldId="268"/>
            <ac:picMk id="14" creationId="{656D42B7-C87A-4C3C-9961-B91E0B263256}"/>
          </ac:picMkLst>
        </pc:picChg>
      </pc:sldChg>
      <pc:sldChg chg="addSp delSp modSp add mod">
        <pc:chgData name="Elin Lindström" userId="723b82ab-0209-45d5-96e3-8656267ad461" providerId="ADAL" clId="{F331B6A3-0612-495D-A603-D2BFBF313FAE}" dt="2022-07-06T07:47:58.642" v="1232" actId="403"/>
        <pc:sldMkLst>
          <pc:docMk/>
          <pc:sldMk cId="4078755457" sldId="269"/>
        </pc:sldMkLst>
        <pc:spChg chg="add mod">
          <ac:chgData name="Elin Lindström" userId="723b82ab-0209-45d5-96e3-8656267ad461" providerId="ADAL" clId="{F331B6A3-0612-495D-A603-D2BFBF313FAE}" dt="2022-07-06T07:47:58.642" v="1232" actId="403"/>
          <ac:spMkLst>
            <pc:docMk/>
            <pc:sldMk cId="4078755457" sldId="269"/>
            <ac:spMk id="2" creationId="{819AFF02-F42B-4949-A0F9-03BD490747BF}"/>
          </ac:spMkLst>
        </pc:spChg>
        <pc:spChg chg="del">
          <ac:chgData name="Elin Lindström" userId="723b82ab-0209-45d5-96e3-8656267ad461" providerId="ADAL" clId="{F331B6A3-0612-495D-A603-D2BFBF313FAE}" dt="2022-06-27T14:16:59.990" v="573"/>
          <ac:spMkLst>
            <pc:docMk/>
            <pc:sldMk cId="4078755457" sldId="269"/>
            <ac:spMk id="2" creationId="{E008A45B-507E-4620-89D2-4D26BF5FBD07}"/>
          </ac:spMkLst>
        </pc:spChg>
        <pc:spChg chg="add mod">
          <ac:chgData name="Elin Lindström" userId="723b82ab-0209-45d5-96e3-8656267ad461" providerId="ADAL" clId="{F331B6A3-0612-495D-A603-D2BFBF313FAE}" dt="2022-07-06T07:46:32.995" v="1207" actId="1076"/>
          <ac:spMkLst>
            <pc:docMk/>
            <pc:sldMk cId="4078755457" sldId="269"/>
            <ac:spMk id="6" creationId="{7BE345F4-9276-4EAA-8266-F85B98BC2ED9}"/>
          </ac:spMkLst>
        </pc:spChg>
        <pc:spChg chg="del">
          <ac:chgData name="Elin Lindström" userId="723b82ab-0209-45d5-96e3-8656267ad461" providerId="ADAL" clId="{F331B6A3-0612-495D-A603-D2BFBF313FAE}" dt="2022-06-27T14:05:48.185" v="533" actId="478"/>
          <ac:spMkLst>
            <pc:docMk/>
            <pc:sldMk cId="4078755457" sldId="269"/>
            <ac:spMk id="12" creationId="{87FEBA38-BA13-4D33-9F30-756D27D7A099}"/>
          </ac:spMkLst>
        </pc:spChg>
        <pc:spChg chg="del">
          <ac:chgData name="Elin Lindström" userId="723b82ab-0209-45d5-96e3-8656267ad461" providerId="ADAL" clId="{F331B6A3-0612-495D-A603-D2BFBF313FAE}" dt="2022-06-27T14:05:49.311" v="534" actId="478"/>
          <ac:spMkLst>
            <pc:docMk/>
            <pc:sldMk cId="4078755457" sldId="269"/>
            <ac:spMk id="13" creationId="{B98EBCF9-3842-4706-A28B-057B5278E335}"/>
          </ac:spMkLst>
        </pc:spChg>
        <pc:spChg chg="add del mod">
          <ac:chgData name="Elin Lindström" userId="723b82ab-0209-45d5-96e3-8656267ad461" providerId="ADAL" clId="{F331B6A3-0612-495D-A603-D2BFBF313FAE}" dt="2022-07-06T07:47:49.962" v="1226" actId="478"/>
          <ac:spMkLst>
            <pc:docMk/>
            <pc:sldMk cId="4078755457" sldId="269"/>
            <ac:spMk id="15" creationId="{353BA9A8-4F98-4A59-9B7C-5B4144AC5D7E}"/>
          </ac:spMkLst>
        </pc:spChg>
        <pc:spChg chg="add mod">
          <ac:chgData name="Elin Lindström" userId="723b82ab-0209-45d5-96e3-8656267ad461" providerId="ADAL" clId="{F331B6A3-0612-495D-A603-D2BFBF313FAE}" dt="2022-06-29T11:45:08.677" v="1118" actId="1076"/>
          <ac:spMkLst>
            <pc:docMk/>
            <pc:sldMk cId="4078755457" sldId="269"/>
            <ac:spMk id="18" creationId="{BBF08099-67AF-4469-BB3A-58F51ED76744}"/>
          </ac:spMkLst>
        </pc:spChg>
        <pc:spChg chg="add mod">
          <ac:chgData name="Elin Lindström" userId="723b82ab-0209-45d5-96e3-8656267ad461" providerId="ADAL" clId="{F331B6A3-0612-495D-A603-D2BFBF313FAE}" dt="2022-06-29T11:45:08.677" v="1118" actId="1076"/>
          <ac:spMkLst>
            <pc:docMk/>
            <pc:sldMk cId="4078755457" sldId="269"/>
            <ac:spMk id="19" creationId="{CC2AF70A-FA4F-4763-94FD-5D3A8D7B5DD0}"/>
          </ac:spMkLst>
        </pc:spChg>
        <pc:spChg chg="add del mod">
          <ac:chgData name="Elin Lindström" userId="723b82ab-0209-45d5-96e3-8656267ad461" providerId="ADAL" clId="{F331B6A3-0612-495D-A603-D2BFBF313FAE}" dt="2022-06-27T14:17:49.278" v="588" actId="478"/>
          <ac:spMkLst>
            <pc:docMk/>
            <pc:sldMk cId="4078755457" sldId="269"/>
            <ac:spMk id="20" creationId="{9210E3FD-DE64-4786-95E4-1732FB10DFF4}"/>
          </ac:spMkLst>
        </pc:spChg>
        <pc:spChg chg="add mod">
          <ac:chgData name="Elin Lindström" userId="723b82ab-0209-45d5-96e3-8656267ad461" providerId="ADAL" clId="{F331B6A3-0612-495D-A603-D2BFBF313FAE}" dt="2022-07-06T07:47:11.567" v="1209" actId="1036"/>
          <ac:spMkLst>
            <pc:docMk/>
            <pc:sldMk cId="4078755457" sldId="269"/>
            <ac:spMk id="21" creationId="{A80A8BD5-864D-4369-8845-9B60E79A5463}"/>
          </ac:spMkLst>
        </pc:spChg>
        <pc:spChg chg="add mod">
          <ac:chgData name="Elin Lindström" userId="723b82ab-0209-45d5-96e3-8656267ad461" providerId="ADAL" clId="{F331B6A3-0612-495D-A603-D2BFBF313FAE}" dt="2022-07-06T07:47:11.567" v="1209" actId="1036"/>
          <ac:spMkLst>
            <pc:docMk/>
            <pc:sldMk cId="4078755457" sldId="269"/>
            <ac:spMk id="22" creationId="{DC318293-DDF8-410E-ADE9-35DE88D3A208}"/>
          </ac:spMkLst>
        </pc:spChg>
        <pc:spChg chg="add mod">
          <ac:chgData name="Elin Lindström" userId="723b82ab-0209-45d5-96e3-8656267ad461" providerId="ADAL" clId="{F331B6A3-0612-495D-A603-D2BFBF313FAE}" dt="2022-07-06T07:47:11.567" v="1209" actId="1036"/>
          <ac:spMkLst>
            <pc:docMk/>
            <pc:sldMk cId="4078755457" sldId="269"/>
            <ac:spMk id="23" creationId="{54C236B3-4F95-438C-80BC-D69D807085F5}"/>
          </ac:spMkLst>
        </pc:spChg>
        <pc:spChg chg="mod">
          <ac:chgData name="Elin Lindström" userId="723b82ab-0209-45d5-96e3-8656267ad461" providerId="ADAL" clId="{F331B6A3-0612-495D-A603-D2BFBF313FAE}" dt="2022-07-06T07:47:25.681" v="1211"/>
          <ac:spMkLst>
            <pc:docMk/>
            <pc:sldMk cId="4078755457" sldId="269"/>
            <ac:spMk id="25" creationId="{7A31B410-A5ED-4FCA-86E0-4094AB53F216}"/>
          </ac:spMkLst>
        </pc:spChg>
        <pc:spChg chg="mod">
          <ac:chgData name="Elin Lindström" userId="723b82ab-0209-45d5-96e3-8656267ad461" providerId="ADAL" clId="{F331B6A3-0612-495D-A603-D2BFBF313FAE}" dt="2022-07-06T07:47:25.681" v="1211"/>
          <ac:spMkLst>
            <pc:docMk/>
            <pc:sldMk cId="4078755457" sldId="269"/>
            <ac:spMk id="26" creationId="{F18DA5CE-7730-448C-AD1C-164359253A7C}"/>
          </ac:spMkLst>
        </pc:spChg>
        <pc:spChg chg="mod">
          <ac:chgData name="Elin Lindström" userId="723b82ab-0209-45d5-96e3-8656267ad461" providerId="ADAL" clId="{F331B6A3-0612-495D-A603-D2BFBF313FAE}" dt="2022-07-06T07:47:25.681" v="1211"/>
          <ac:spMkLst>
            <pc:docMk/>
            <pc:sldMk cId="4078755457" sldId="269"/>
            <ac:spMk id="27" creationId="{9F5DC5B3-E4A6-4079-8864-113FE8B39FB2}"/>
          </ac:spMkLst>
        </pc:spChg>
        <pc:spChg chg="mod">
          <ac:chgData name="Elin Lindström" userId="723b82ab-0209-45d5-96e3-8656267ad461" providerId="ADAL" clId="{F331B6A3-0612-495D-A603-D2BFBF313FAE}" dt="2022-07-06T07:47:25.681" v="1211"/>
          <ac:spMkLst>
            <pc:docMk/>
            <pc:sldMk cId="4078755457" sldId="269"/>
            <ac:spMk id="28" creationId="{A9763305-DFB9-4C20-B301-034D10FB9405}"/>
          </ac:spMkLst>
        </pc:spChg>
        <pc:spChg chg="mod">
          <ac:chgData name="Elin Lindström" userId="723b82ab-0209-45d5-96e3-8656267ad461" providerId="ADAL" clId="{F331B6A3-0612-495D-A603-D2BFBF313FAE}" dt="2022-07-06T07:47:25.681" v="1211"/>
          <ac:spMkLst>
            <pc:docMk/>
            <pc:sldMk cId="4078755457" sldId="269"/>
            <ac:spMk id="29" creationId="{05807D49-6215-4D06-AE0D-37320B655EFD}"/>
          </ac:spMkLst>
        </pc:spChg>
        <pc:spChg chg="mod">
          <ac:chgData name="Elin Lindström" userId="723b82ab-0209-45d5-96e3-8656267ad461" providerId="ADAL" clId="{F331B6A3-0612-495D-A603-D2BFBF313FAE}" dt="2022-07-06T07:47:25.681" v="1211"/>
          <ac:spMkLst>
            <pc:docMk/>
            <pc:sldMk cId="4078755457" sldId="269"/>
            <ac:spMk id="30" creationId="{C6AEEE72-A1DF-4812-8993-4D2337D37CDF}"/>
          </ac:spMkLst>
        </pc:spChg>
        <pc:grpChg chg="add del mod">
          <ac:chgData name="Elin Lindström" userId="723b82ab-0209-45d5-96e3-8656267ad461" providerId="ADAL" clId="{F331B6A3-0612-495D-A603-D2BFBF313FAE}" dt="2022-07-06T07:47:28.153" v="1212"/>
          <ac:grpSpMkLst>
            <pc:docMk/>
            <pc:sldMk cId="4078755457" sldId="269"/>
            <ac:grpSpMk id="20" creationId="{29E68B95-F77B-4D1E-A882-AAE2F834D44C}"/>
          </ac:grpSpMkLst>
        </pc:grpChg>
        <pc:grpChg chg="add del mod">
          <ac:chgData name="Elin Lindström" userId="723b82ab-0209-45d5-96e3-8656267ad461" providerId="ADAL" clId="{F331B6A3-0612-495D-A603-D2BFBF313FAE}" dt="2022-07-06T07:47:23.943" v="1210" actId="21"/>
          <ac:grpSpMkLst>
            <pc:docMk/>
            <pc:sldMk cId="4078755457" sldId="269"/>
            <ac:grpSpMk id="24" creationId="{075B6CAF-CBD7-45BA-8D7D-FAD69B6A8FE8}"/>
          </ac:grpSpMkLst>
        </pc:grpChg>
        <pc:picChg chg="add mod">
          <ac:chgData name="Elin Lindström" userId="723b82ab-0209-45d5-96e3-8656267ad461" providerId="ADAL" clId="{F331B6A3-0612-495D-A603-D2BFBF313FAE}" dt="2022-07-06T07:47:32.008" v="1225" actId="1036"/>
          <ac:picMkLst>
            <pc:docMk/>
            <pc:sldMk cId="4078755457" sldId="269"/>
            <ac:picMk id="3" creationId="{C62B0435-E7DE-401C-A549-EF34E201D93D}"/>
          </ac:picMkLst>
        </pc:picChg>
        <pc:picChg chg="add del mod">
          <ac:chgData name="Elin Lindström" userId="723b82ab-0209-45d5-96e3-8656267ad461" providerId="ADAL" clId="{F331B6A3-0612-495D-A603-D2BFBF313FAE}" dt="2022-07-06T07:47:23.943" v="1210" actId="21"/>
          <ac:picMkLst>
            <pc:docMk/>
            <pc:sldMk cId="4078755457" sldId="269"/>
            <ac:picMk id="5" creationId="{A6881DA5-2C0D-4EB2-9627-5C91BD7F8643}"/>
          </ac:picMkLst>
        </pc:picChg>
        <pc:picChg chg="del">
          <ac:chgData name="Elin Lindström" userId="723b82ab-0209-45d5-96e3-8656267ad461" providerId="ADAL" clId="{F331B6A3-0612-495D-A603-D2BFBF313FAE}" dt="2022-06-27T14:05:46.633" v="532" actId="478"/>
          <ac:picMkLst>
            <pc:docMk/>
            <pc:sldMk cId="4078755457" sldId="269"/>
            <ac:picMk id="9" creationId="{08C29C1D-22C4-4FD4-BFDD-CE504F037ADE}"/>
          </ac:picMkLst>
        </pc:picChg>
        <pc:picChg chg="add del mod modCrop">
          <ac:chgData name="Elin Lindström" userId="723b82ab-0209-45d5-96e3-8656267ad461" providerId="ADAL" clId="{F331B6A3-0612-495D-A603-D2BFBF313FAE}" dt="2022-06-27T14:17:07.017" v="575" actId="478"/>
          <ac:picMkLst>
            <pc:docMk/>
            <pc:sldMk cId="4078755457" sldId="269"/>
            <ac:picMk id="14" creationId="{E02B405A-C8E8-4582-B2D7-88B856A5B086}"/>
          </ac:picMkLst>
        </pc:picChg>
        <pc:picChg chg="add del mod modCrop">
          <ac:chgData name="Elin Lindström" userId="723b82ab-0209-45d5-96e3-8656267ad461" providerId="ADAL" clId="{F331B6A3-0612-495D-A603-D2BFBF313FAE}" dt="2022-06-27T14:17:07.017" v="575" actId="478"/>
          <ac:picMkLst>
            <pc:docMk/>
            <pc:sldMk cId="4078755457" sldId="269"/>
            <ac:picMk id="15" creationId="{544CEB79-DD7C-474B-A67E-494C67F1A7B3}"/>
          </ac:picMkLst>
        </pc:picChg>
        <pc:picChg chg="add del mod modCrop">
          <ac:chgData name="Elin Lindström" userId="723b82ab-0209-45d5-96e3-8656267ad461" providerId="ADAL" clId="{F331B6A3-0612-495D-A603-D2BFBF313FAE}" dt="2022-06-27T14:17:07.017" v="575" actId="478"/>
          <ac:picMkLst>
            <pc:docMk/>
            <pc:sldMk cId="4078755457" sldId="269"/>
            <ac:picMk id="16" creationId="{DB0E81B1-3937-469C-AB15-52F94C7EAA66}"/>
          </ac:picMkLst>
        </pc:picChg>
        <pc:picChg chg="add del mod modCrop">
          <ac:chgData name="Elin Lindström" userId="723b82ab-0209-45d5-96e3-8656267ad461" providerId="ADAL" clId="{F331B6A3-0612-495D-A603-D2BFBF313FAE}" dt="2022-06-27T14:17:07.017" v="575" actId="478"/>
          <ac:picMkLst>
            <pc:docMk/>
            <pc:sldMk cId="4078755457" sldId="269"/>
            <ac:picMk id="17" creationId="{CE5E8D6B-52CE-485B-9E9E-63D20F48C502}"/>
          </ac:picMkLst>
        </pc:picChg>
        <pc:picChg chg="add del mod">
          <ac:chgData name="Elin Lindström" userId="723b82ab-0209-45d5-96e3-8656267ad461" providerId="ADAL" clId="{F331B6A3-0612-495D-A603-D2BFBF313FAE}" dt="2022-07-06T07:47:28.153" v="1212"/>
          <ac:picMkLst>
            <pc:docMk/>
            <pc:sldMk cId="4078755457" sldId="269"/>
            <ac:picMk id="17" creationId="{FFE7EF90-8DF0-4731-A47B-D79265247920}"/>
          </ac:picMkLst>
        </pc:pic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6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24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fluence of image reconstruction on quantitative cardiac </a:t>
            </a:r>
            <a:r>
              <a:rPr lang="en-US" sz="2400" b="1" i="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sz="24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-water positron emission tomography</a:t>
            </a:r>
            <a:endParaRPr lang="en-US" altLang="en-US" sz="1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2000" dirty="0"/>
              <a:t>Jonny </a:t>
            </a:r>
            <a:r>
              <a:rPr lang="en-US" altLang="en-US" sz="2000" dirty="0" err="1"/>
              <a:t>Nordström</a:t>
            </a:r>
            <a:r>
              <a:rPr lang="en-US" altLang="en-US" sz="2000" dirty="0"/>
              <a:t>*, Elin Lindström*, Tanja Kero, Jens Sörensen, Mark Lubberink </a:t>
            </a:r>
          </a:p>
          <a:p>
            <a:pPr marL="0" lvl="1"/>
            <a:r>
              <a:rPr lang="en-US" altLang="en-US" sz="2000" dirty="0"/>
              <a:t>Uppsala University</a:t>
            </a:r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>
            <a:extLst>
              <a:ext uri="{FF2B5EF4-FFF2-40B4-BE49-F238E27FC236}">
                <a16:creationId xmlns:a16="http://schemas.microsoft.com/office/drawing/2014/main" id="{238951FD-718A-4BFD-97B7-6A08221B5C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4291012"/>
            <a:ext cx="1476375" cy="1476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 descr="Jonny NORDSTRÖM | PhD | Uppsala University, Uppsala | UU | Department of  Surgical Sciences / Nuclear Medicine &amp; PET">
            <a:extLst>
              <a:ext uri="{FF2B5EF4-FFF2-40B4-BE49-F238E27FC236}">
                <a16:creationId xmlns:a16="http://schemas.microsoft.com/office/drawing/2014/main" id="{A1341921-491F-4F68-AFF8-FA7AC03034C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93" t="3315" r="8166" b="5056"/>
          <a:stretch/>
        </p:blipFill>
        <p:spPr bwMode="auto">
          <a:xfrm>
            <a:off x="1214209" y="4165505"/>
            <a:ext cx="1476377" cy="16077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Bildobjekt 6" descr="En bild som visar inomhus&#10;&#10;Automatiskt genererad beskrivning">
            <a:extLst>
              <a:ext uri="{FF2B5EF4-FFF2-40B4-BE49-F238E27FC236}">
                <a16:creationId xmlns:a16="http://schemas.microsoft.com/office/drawing/2014/main" id="{286EE8F4-570E-41D9-9468-3F14CA8F361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67" r="4189" b="2109"/>
          <a:stretch/>
        </p:blipFill>
        <p:spPr>
          <a:xfrm rot="16200000">
            <a:off x="2815542" y="4239897"/>
            <a:ext cx="1607743" cy="1476376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endParaRPr lang="en-US" altLang="en-US" sz="2400" dirty="0"/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/>
              <a:t>PET with </a:t>
            </a:r>
            <a:r>
              <a:rPr lang="en-US" altLang="en-US" sz="2400" baseline="30000" dirty="0"/>
              <a:t>15</a:t>
            </a:r>
            <a:r>
              <a:rPr lang="en-US" altLang="en-US" sz="2400" dirty="0"/>
              <a:t>O-water is a valuable noninvasive tool for both diagnosis and risk stratification of coronary artery disease 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/>
              <a:t>Uniform absolute diagnostic threshold for pathological hyperemic MBF in clinical decision making requires robust quantification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/>
              <a:t>Different types of PET image reconstructions influences both image quality and quantification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type: Retrospective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subjects: Clinical stress </a:t>
            </a:r>
            <a:r>
              <a:rPr lang="en-US" altLang="en-US" sz="2400" baseline="30000" dirty="0"/>
              <a:t>15</a:t>
            </a:r>
            <a:r>
              <a:rPr lang="en-US" altLang="en-US" sz="2400" dirty="0"/>
              <a:t>O-water PET/CT scans (n=20)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endpoints:</a:t>
            </a:r>
          </a:p>
          <a:p>
            <a:pPr marL="914400" lvl="1" indent="-514350">
              <a:buFont typeface="+mj-lt"/>
              <a:buAutoNum type="romanLcPeriod"/>
            </a:pPr>
            <a:r>
              <a:rPr lang="en-US" altLang="en-US" sz="2400" dirty="0"/>
              <a:t>Primary end point: Study impact of reconstruction on quantitative measures</a:t>
            </a:r>
          </a:p>
          <a:p>
            <a:pPr marL="914400" lvl="1" indent="-514350">
              <a:buFont typeface="+mj-lt"/>
              <a:buAutoNum type="romanLcPeriod"/>
            </a:pPr>
            <a:r>
              <a:rPr lang="en-US" altLang="en-US" sz="2400" dirty="0"/>
              <a:t>Secondary end point: Evaluate possible change of diagnosis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variables: MBF, PTF, MBFt evaluated for 22 different reconstruction method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ktangel 5">
            <a:extLst>
              <a:ext uri="{FF2B5EF4-FFF2-40B4-BE49-F238E27FC236}">
                <a16:creationId xmlns:a16="http://schemas.microsoft.com/office/drawing/2014/main" id="{BE11B163-3389-4FBA-B2CD-B34182703C67}"/>
              </a:ext>
            </a:extLst>
          </p:cNvPr>
          <p:cNvSpPr/>
          <p:nvPr/>
        </p:nvSpPr>
        <p:spPr>
          <a:xfrm>
            <a:off x="685800" y="2438400"/>
            <a:ext cx="4258363" cy="3502462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Platshållare för innehåll 1">
            <a:extLst>
              <a:ext uri="{FF2B5EF4-FFF2-40B4-BE49-F238E27FC236}">
                <a16:creationId xmlns:a16="http://schemas.microsoft.com/office/drawing/2014/main" id="{8947D6FB-4FF8-4938-A5DD-B64573F53F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600200"/>
            <a:ext cx="8001000" cy="4525963"/>
          </a:xfrm>
        </p:spPr>
        <p:txBody>
          <a:bodyPr/>
          <a:lstStyle/>
          <a:p>
            <a:pPr marL="0" indent="0">
              <a:buNone/>
            </a:pPr>
            <a:r>
              <a:rPr lang="en-US" sz="2400" dirty="0"/>
              <a:t>MBF polar plots with different reconstruction methods</a:t>
            </a:r>
          </a:p>
        </p:txBody>
      </p:sp>
      <p:pic>
        <p:nvPicPr>
          <p:cNvPr id="3" name="Bildobjekt 2">
            <a:extLst>
              <a:ext uri="{FF2B5EF4-FFF2-40B4-BE49-F238E27FC236}">
                <a16:creationId xmlns:a16="http://schemas.microsoft.com/office/drawing/2014/main" id="{5DBF7D41-35FE-4F9C-B557-1E11E16600F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130"/>
          <a:stretch/>
        </p:blipFill>
        <p:spPr>
          <a:xfrm>
            <a:off x="4859126" y="2438400"/>
            <a:ext cx="3578662" cy="3502462"/>
          </a:xfrm>
          <a:prstGeom prst="rect">
            <a:avLst/>
          </a:prstGeom>
        </p:spPr>
      </p:pic>
      <p:sp>
        <p:nvSpPr>
          <p:cNvPr id="5" name="textruta 4">
            <a:extLst>
              <a:ext uri="{FF2B5EF4-FFF2-40B4-BE49-F238E27FC236}">
                <a16:creationId xmlns:a16="http://schemas.microsoft.com/office/drawing/2014/main" id="{DA2B875C-F9FB-483A-AE0A-0012ADF0226E}"/>
              </a:ext>
            </a:extLst>
          </p:cNvPr>
          <p:cNvSpPr txBox="1"/>
          <p:nvPr/>
        </p:nvSpPr>
        <p:spPr>
          <a:xfrm>
            <a:off x="803649" y="2895600"/>
            <a:ext cx="36789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</a:rPr>
              <a:t>OSEM with and without TOF and PSF</a:t>
            </a:r>
          </a:p>
        </p:txBody>
      </p:sp>
      <p:sp>
        <p:nvSpPr>
          <p:cNvPr id="15" name="textruta 14">
            <a:extLst>
              <a:ext uri="{FF2B5EF4-FFF2-40B4-BE49-F238E27FC236}">
                <a16:creationId xmlns:a16="http://schemas.microsoft.com/office/drawing/2014/main" id="{9BD947E6-B5C9-4F52-95CF-75DB87D7473F}"/>
              </a:ext>
            </a:extLst>
          </p:cNvPr>
          <p:cNvSpPr txBox="1"/>
          <p:nvPr/>
        </p:nvSpPr>
        <p:spPr>
          <a:xfrm>
            <a:off x="808002" y="3966865"/>
            <a:ext cx="367896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</a:rPr>
              <a:t>OSEM with different number of iterations</a:t>
            </a:r>
          </a:p>
        </p:txBody>
      </p:sp>
      <p:sp>
        <p:nvSpPr>
          <p:cNvPr id="16" name="textruta 15">
            <a:extLst>
              <a:ext uri="{FF2B5EF4-FFF2-40B4-BE49-F238E27FC236}">
                <a16:creationId xmlns:a16="http://schemas.microsoft.com/office/drawing/2014/main" id="{B7040341-421D-4127-8834-6C589EF6C1D4}"/>
              </a:ext>
            </a:extLst>
          </p:cNvPr>
          <p:cNvSpPr txBox="1"/>
          <p:nvPr/>
        </p:nvSpPr>
        <p:spPr>
          <a:xfrm>
            <a:off x="800383" y="5159029"/>
            <a:ext cx="405874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</a:rPr>
              <a:t>Regularized reconstruction with different regularization parameter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Platshållare för innehåll 1">
            <a:extLst>
              <a:ext uri="{FF2B5EF4-FFF2-40B4-BE49-F238E27FC236}">
                <a16:creationId xmlns:a16="http://schemas.microsoft.com/office/drawing/2014/main" id="{819AFF02-F42B-4949-A0F9-03BD490747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altLang="en-US" sz="2400" kern="0" dirty="0"/>
              <a:t>Heat maps showing median bias % of MBF, PTF and MBFt between all 22 reconstruction methods </a:t>
            </a:r>
          </a:p>
          <a:p>
            <a:endParaRPr lang="en-US" sz="2400" dirty="0"/>
          </a:p>
        </p:txBody>
      </p:sp>
      <p:pic>
        <p:nvPicPr>
          <p:cNvPr id="3" name="Bildobjekt 2">
            <a:extLst>
              <a:ext uri="{FF2B5EF4-FFF2-40B4-BE49-F238E27FC236}">
                <a16:creationId xmlns:a16="http://schemas.microsoft.com/office/drawing/2014/main" id="{C62B0435-E7DE-401C-A549-EF34E201D93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3727" y="2444166"/>
            <a:ext cx="8876545" cy="38042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87554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sz="20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Changes in reconstruction settings such as filter size, number of iterations, inclusion of time of flight or resolution recovery, and regularization, have minor impact on MBF values based on </a:t>
            </a:r>
            <a:r>
              <a:rPr lang="en-US" sz="2000" baseline="300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15</a:t>
            </a:r>
            <a:r>
              <a:rPr lang="en-US" sz="20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O-water PET analyzed using automated software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sz="2000" dirty="0"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lang="en-US" sz="20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iagnosis was unchanged irrespective of reconstruction method in all patients except for one, where only four of the most extreme reconstruction methods resulted in a change of diagnosis</a:t>
            </a:r>
            <a:endParaRPr lang="en-US" altLang="en-US" sz="2800" dirty="0"/>
          </a:p>
          <a:p>
            <a:pPr marL="0" indent="0" algn="ctr">
              <a:buNone/>
            </a:pPr>
            <a:endParaRPr lang="en-US" altLang="en-US" sz="2000" b="1" dirty="0"/>
          </a:p>
          <a:p>
            <a:pPr marL="0" indent="0" algn="ctr">
              <a:buNone/>
            </a:pPr>
            <a:r>
              <a:rPr lang="en-US" altLang="en-US" sz="2000" b="1" dirty="0"/>
              <a:t>New Knowledge Gained</a:t>
            </a:r>
          </a:p>
          <a:p>
            <a:pPr marL="0" indent="0" algn="ctr">
              <a:buNone/>
            </a:pPr>
            <a:r>
              <a:rPr lang="en-US" altLang="en-US" sz="2000" dirty="0"/>
              <a:t>MBF from </a:t>
            </a:r>
            <a:r>
              <a:rPr lang="en-US" altLang="en-US" sz="2000" baseline="30000" dirty="0"/>
              <a:t>15</a:t>
            </a:r>
            <a:r>
              <a:rPr lang="en-US" altLang="en-US" sz="2000" dirty="0"/>
              <a:t>O-water PET is minimally affected by the choice of image reconstruction algorithm and the diagnostic cutoff can consistently be used across a wide range of reconstructions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DD9E3C84E7A07046933A120C880873D8" ma:contentTypeVersion="13" ma:contentTypeDescription="Skapa ett nytt dokument." ma:contentTypeScope="" ma:versionID="9988a0d533808ab3f8f2466f6b4282db">
  <xsd:schema xmlns:xsd="http://www.w3.org/2001/XMLSchema" xmlns:xs="http://www.w3.org/2001/XMLSchema" xmlns:p="http://schemas.microsoft.com/office/2006/metadata/properties" xmlns:ns2="7b809947-770c-44a5-92fe-a48f14e71d28" xmlns:ns3="1674eefb-b9d5-45d5-b5eb-dc057ab26a05" targetNamespace="http://schemas.microsoft.com/office/2006/metadata/properties" ma:root="true" ma:fieldsID="944814d05f2780cc7bc0036275995131" ns2:_="" ns3:_="">
    <xsd:import namespace="7b809947-770c-44a5-92fe-a48f14e71d28"/>
    <xsd:import namespace="1674eefb-b9d5-45d5-b5eb-dc057ab26a05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MediaServiceLocatio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b809947-770c-44a5-92fe-a48f14e71d2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19" nillable="true" ma:displayName="Location" ma:internalName="MediaServiceLocatio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674eefb-b9d5-45d5-b5eb-dc057ab26a05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Delat med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Delat med information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nehållstyp"/>
        <xsd:element ref="dc:title" minOccurs="0" maxOccurs="1" ma:index="4" ma:displayName="Rubrik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A7B0BB6-87C8-4843-A313-86ABE6101F21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23699581-74FD-4682-877B-C4A454B2CE0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b809947-770c-44a5-92fe-a48f14e71d28"/>
    <ds:schemaRef ds:uri="1674eefb-b9d5-45d5-b5eb-dc057ab26a0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E529574-43A4-4F83-A812-FBD73032939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2</TotalTime>
  <Words>396</Words>
  <Application>Microsoft Office PowerPoint</Application>
  <PresentationFormat>Bildspel på skärmen (4:3)</PresentationFormat>
  <Paragraphs>40</Paragraphs>
  <Slides>6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5</vt:i4>
      </vt:variant>
      <vt:variant>
        <vt:lpstr>Tema</vt:lpstr>
      </vt:variant>
      <vt:variant>
        <vt:i4>3</vt:i4>
      </vt:variant>
      <vt:variant>
        <vt:lpstr>Bildrubriker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Influence of image reconstruction on quantitative cardiac 15O-water positron emission tomography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Elin Lindström</cp:lastModifiedBy>
  <cp:revision>97</cp:revision>
  <dcterms:created xsi:type="dcterms:W3CDTF">2011-04-18T21:44:13Z</dcterms:created>
  <dcterms:modified xsi:type="dcterms:W3CDTF">2022-07-06T07:59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D9E3C84E7A07046933A120C880873D8</vt:lpwstr>
  </property>
</Properties>
</file>